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47" d="100"/>
          <a:sy n="47" d="100"/>
        </p:scale>
        <p:origin x="-2430" y="-9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1B46F-F548-4FAE-8923-84FC41A057FC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0F18C-2D8A-47C2-9E0D-24DDE0B37F0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1B46F-F548-4FAE-8923-84FC41A057FC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0F18C-2D8A-47C2-9E0D-24DDE0B37F0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1B46F-F548-4FAE-8923-84FC41A057FC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0F18C-2D8A-47C2-9E0D-24DDE0B37F0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1B46F-F548-4FAE-8923-84FC41A057FC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0F18C-2D8A-47C2-9E0D-24DDE0B37F0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1B46F-F548-4FAE-8923-84FC41A057FC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0F18C-2D8A-47C2-9E0D-24DDE0B37F0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1B46F-F548-4FAE-8923-84FC41A057FC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0F18C-2D8A-47C2-9E0D-24DDE0B37F0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1B46F-F548-4FAE-8923-84FC41A057FC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0F18C-2D8A-47C2-9E0D-24DDE0B37F0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1B46F-F548-4FAE-8923-84FC41A057FC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0F18C-2D8A-47C2-9E0D-24DDE0B37F0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1B46F-F548-4FAE-8923-84FC41A057FC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0F18C-2D8A-47C2-9E0D-24DDE0B37F0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1B46F-F548-4FAE-8923-84FC41A057FC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0F18C-2D8A-47C2-9E0D-24DDE0B37F0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1B46F-F548-4FAE-8923-84FC41A057FC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C0F18C-2D8A-47C2-9E0D-24DDE0B37F0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01B46F-F548-4FAE-8923-84FC41A057FC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C0F18C-2D8A-47C2-9E0D-24DDE0B37F07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Text Box 4"/>
          <p:cNvSpPr txBox="1">
            <a:spLocks noChangeArrowheads="1"/>
          </p:cNvSpPr>
          <p:nvPr/>
        </p:nvSpPr>
        <p:spPr bwMode="auto">
          <a:xfrm>
            <a:off x="260350" y="174625"/>
            <a:ext cx="6477000" cy="9602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>
              <a:lnSpc>
                <a:spcPct val="45000"/>
              </a:lnSpc>
              <a:spcBef>
                <a:spcPct val="50000"/>
              </a:spcBef>
            </a:pPr>
            <a:endParaRPr lang="zh-TW" altLang="en-US" sz="1000" dirty="0">
              <a:latin typeface="Courier New" pitchFamily="49" charset="0"/>
              <a:ea typeface="新細明體" pitchFamily="18" charset="-120"/>
            </a:endParaRP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zh-TW" altLang="en-US" sz="1000" dirty="0">
                <a:latin typeface="Courier New" pitchFamily="49" charset="0"/>
                <a:ea typeface="新細明體" pitchFamily="18" charset="-120"/>
              </a:rPr>
              <a:t>   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-60					          g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-59	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</a:rPr>
              <a:t>gacttccagtgcaaatccgacacttgcttggttggatttataatgtacaatcagtactc</a:t>
            </a:r>
            <a:endParaRPr lang="en-US" altLang="zh-TW" sz="1000" dirty="0">
              <a:latin typeface="Courier New" pitchFamily="49" charset="0"/>
              <a:ea typeface="新細明體" pitchFamily="18" charset="-120"/>
            </a:endParaRP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	 </a:t>
            </a:r>
            <a:r>
              <a:rPr lang="en-US" altLang="zh-TW" sz="1000" b="1" dirty="0">
                <a:latin typeface="Courier New" pitchFamily="49" charset="0"/>
                <a:ea typeface="新細明體" pitchFamily="18" charset="-120"/>
              </a:rPr>
              <a:t>M   F   L   E   L   R   V   </a:t>
            </a:r>
            <a:r>
              <a:rPr lang="en-US" altLang="zh-TW" sz="1000" b="1" dirty="0" err="1">
                <a:latin typeface="Courier New" pitchFamily="49" charset="0"/>
                <a:ea typeface="新細明體" pitchFamily="18" charset="-120"/>
              </a:rPr>
              <a:t>V</a:t>
            </a:r>
            <a:r>
              <a:rPr lang="en-US" altLang="zh-TW" sz="1000" b="1" dirty="0">
                <a:latin typeface="Courier New" pitchFamily="49" charset="0"/>
                <a:ea typeface="新細明體" pitchFamily="18" charset="-120"/>
              </a:rPr>
              <a:t>   F   K   M   W   I   </a:t>
            </a:r>
            <a:r>
              <a:rPr lang="en-US" altLang="zh-TW" sz="1000" b="1" dirty="0" err="1">
                <a:latin typeface="Courier New" pitchFamily="49" charset="0"/>
                <a:ea typeface="新細明體" pitchFamily="18" charset="-120"/>
              </a:rPr>
              <a:t>I</a:t>
            </a:r>
            <a:r>
              <a:rPr lang="en-US" altLang="zh-TW" sz="1000" b="1" dirty="0">
                <a:latin typeface="Courier New" pitchFamily="49" charset="0"/>
                <a:ea typeface="新細明體" pitchFamily="18" charset="-120"/>
              </a:rPr>
              <a:t>   A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   +15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  1	</a:t>
            </a:r>
            <a:r>
              <a:rPr lang="en-US" altLang="zh-TW" sz="1000" b="1" dirty="0">
                <a:latin typeface="Courier New" pitchFamily="49" charset="0"/>
                <a:ea typeface="新細明體" pitchFamily="18" charset="-120"/>
              </a:rPr>
              <a:t>ATG TTT CTG GAA TTA AGG GTC </a:t>
            </a:r>
            <a:r>
              <a:rPr lang="en-US" altLang="zh-TW" sz="1000" b="1" dirty="0" err="1">
                <a:latin typeface="Courier New" pitchFamily="49" charset="0"/>
                <a:ea typeface="新細明體" pitchFamily="18" charset="-120"/>
              </a:rPr>
              <a:t>GTC</a:t>
            </a:r>
            <a:r>
              <a:rPr lang="en-US" altLang="zh-TW" sz="1000" b="1" dirty="0">
                <a:latin typeface="Courier New" pitchFamily="49" charset="0"/>
                <a:ea typeface="新細明體" pitchFamily="18" charset="-120"/>
              </a:rPr>
              <a:t> TTC AAA ATG TGG ATA ATT GCA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	 </a:t>
            </a:r>
            <a:r>
              <a:rPr lang="en-US" altLang="zh-TW" sz="1000" b="1" dirty="0">
                <a:latin typeface="Courier New" pitchFamily="49" charset="0"/>
                <a:ea typeface="新細明體" pitchFamily="18" charset="-120"/>
              </a:rPr>
              <a:t>L   S   L   C   L   E   N   I   </a:t>
            </a:r>
            <a:r>
              <a:rPr lang="en-US" altLang="zh-TW" sz="1000" b="1" dirty="0" err="1">
                <a:latin typeface="Courier New" pitchFamily="49" charset="0"/>
                <a:ea typeface="新細明體" pitchFamily="18" charset="-120"/>
              </a:rPr>
              <a:t>I</a:t>
            </a:r>
            <a:r>
              <a:rPr lang="en-US" altLang="zh-TW" sz="1000" b="1" dirty="0">
                <a:latin typeface="Courier New" pitchFamily="49" charset="0"/>
                <a:ea typeface="新細明體" pitchFamily="18" charset="-120"/>
              </a:rPr>
              <a:t>   L   I   H   A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V   H      +30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 46	</a:t>
            </a:r>
            <a:r>
              <a:rPr lang="en-US" altLang="zh-TW" sz="1000" b="1" dirty="0">
                <a:latin typeface="Courier New" pitchFamily="49" charset="0"/>
                <a:ea typeface="新細明體" pitchFamily="18" charset="-120"/>
              </a:rPr>
              <a:t>CTT TCT CTC TGC CTA GAG AAC ATT ATA TTA ATT CAC GCA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GTT CAT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	 I   E   C   E   L   P   S   I   L   K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</a:rPr>
              <a:t>K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E   K   E   Q      +45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 91	ATT GAA TGT GAG TTG CCC AGT ATA CTT AAG AAA GAA AAG GAG CAA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	 C   F   N   I   L   S   A   E   A   H   N   R   S   E   N      +60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136	TGC TTT AAT ATT TTG TCT GCA GAA GCA CAT AAT AGA TCT GAA AAC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	 Q   E   L   Q   A   G   C   A   G   E   W   D   N   V   T      +75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181	CAA GAG CTG CAA GCA GGC TGT GCT GGA GAG TGG GAT AAT GTA ACA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	 C   W   P   S   A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</a:rPr>
              <a:t>A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V   R   Q   T   V   S   V   P   C      +90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226	TGT TGG CCC TCT GCT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</a:rPr>
              <a:t>GCT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GTA AGA CAG ACT GTC TCT GTA CCC TGT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	 P   E   F   I   S   L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</a:rPr>
              <a:t>L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T   G   V   K   D   F   I   Y      +105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271	CCT GAA TTT ATC TCC CTG CTC ACT GGA GTA AAA GAC TTT ATA TAC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	 R   N   C   T   I   N   G   W   S   E   A   F   P   R   L      +120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316	CGG AAC TGT ACA ATT AAT GGA TGG TCA GAA GCT TTT CCA AGG CTT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	 E   T   A   C   G   Y   K   V   N   D   T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</a:rPr>
              <a:t>T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</a:rPr>
              <a:t>T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D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</a:rPr>
              <a:t>D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   +135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361	GAA ACT GCC TGT GGT TAT AAA GTG AAT GAT ACT ACA ACT GAT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</a:rPr>
              <a:t>GAT</a:t>
            </a:r>
            <a:endParaRPr lang="en-US" altLang="zh-TW" sz="1000" dirty="0">
              <a:latin typeface="Courier New" pitchFamily="49" charset="0"/>
              <a:ea typeface="新細明體" pitchFamily="18" charset="-120"/>
            </a:endParaRP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	 K   T   S   Y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</a:rPr>
              <a:t>Y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S   N   L   K   T   M   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</a:rPr>
              <a:t>Y   T   V   G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   +150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406	AAA ACT TCC TAT TAC TCA AAT TTG AAG ACA ATG TAC ACT GTG GGA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	 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</a:rPr>
              <a:t>Y   S   T   S   F   L   S   L   S   V   A   V   I   </a:t>
            </a:r>
            <a:r>
              <a:rPr lang="en-US" altLang="zh-TW" sz="1000" u="sng" dirty="0" err="1">
                <a:latin typeface="Courier New" pitchFamily="49" charset="0"/>
                <a:ea typeface="新細明體" pitchFamily="18" charset="-120"/>
              </a:rPr>
              <a:t>I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</a:rPr>
              <a:t>   L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   +165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451	TAC AGC ACA TCC TTT CTG TCA TTA TCT GTT GCA GTC ATA ATT CTA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	 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</a:rPr>
              <a:t>G   F   </a:t>
            </a:r>
            <a:r>
              <a:rPr lang="en-US" altLang="zh-TW" sz="1000" u="sng" dirty="0" err="1">
                <a:latin typeface="Courier New" pitchFamily="49" charset="0"/>
                <a:ea typeface="新細明體" pitchFamily="18" charset="-120"/>
              </a:rPr>
              <a:t>F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</a:rPr>
              <a:t>   R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K   L   R   C   T   R   N   Y   I   H   M      +180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496	GGC TTT TTC AGA AAA CTC CGC TGT ACC CGG AAC TAT ATC CAC ATG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	 H   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</a:rPr>
              <a:t>L   F   T   S   F   I   L   R   A   L   S   V   L   I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   +195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541	CAT TTG TTT ACA TCA TTT ATT CTG CGA GCT CTT TCA GTG CTT ATC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	 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</a:rPr>
              <a:t>K   D   S   V   L   F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S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</a:rPr>
              <a:t>S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K   D   I   D   H   C   S      +210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586	AAG GAT AGT GTC TTG TTT TCC AGC AAA GAC ATT GAT CAC TGC AGC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	 A   Y   A   S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</a:rPr>
              <a:t>S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G   C   K   F   V   </a:t>
            </a:r>
            <a:r>
              <a:rPr lang="en-US" altLang="zh-TW" sz="1000" u="sng" dirty="0" err="1">
                <a:latin typeface="Courier New" pitchFamily="49" charset="0"/>
                <a:ea typeface="新細明體" pitchFamily="18" charset="-120"/>
              </a:rPr>
              <a:t>V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</a:rPr>
              <a:t>   </a:t>
            </a:r>
            <a:r>
              <a:rPr lang="en-US" altLang="zh-TW" sz="1000" u="sng" dirty="0" err="1">
                <a:latin typeface="Courier New" pitchFamily="49" charset="0"/>
                <a:ea typeface="新細明體" pitchFamily="18" charset="-120"/>
              </a:rPr>
              <a:t>V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</a:rPr>
              <a:t>   F   Y   Q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   +225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631	GCT TAT GCC TCG TCT GGC TGC AAG TTT GTT GTG GTC TTC TAT CAG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	 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</a:rPr>
              <a:t>Y   C   I   M   A   N   Y   S   W   L   </a:t>
            </a:r>
            <a:r>
              <a:rPr lang="en-US" altLang="zh-TW" sz="1000" u="sng" dirty="0" err="1">
                <a:latin typeface="Courier New" pitchFamily="49" charset="0"/>
                <a:ea typeface="新細明體" pitchFamily="18" charset="-120"/>
              </a:rPr>
              <a:t>L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</a:rPr>
              <a:t>   V   E   G   L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   +240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676	TAC TGC ATT ATG GCT AAC TAC AGC TGG CTA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</a:rPr>
              <a:t>CTA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GTG GAA GGA CTC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	 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</a:rPr>
              <a:t>Y   L   H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S   L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</a:rPr>
              <a:t>L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V   I   S   F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</a:rPr>
              <a:t>F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S   E   R   K      +255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721	TAT CTT CAC TCT CTC CTT GTT ATA TCA TTC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</a:rPr>
              <a:t>TTC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TCA GAA AGA AAG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	 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</a:rPr>
              <a:t>Y   F   W   </a:t>
            </a:r>
            <a:r>
              <a:rPr lang="en-US" altLang="zh-TW" sz="1000" u="sng" dirty="0" err="1">
                <a:latin typeface="Courier New" pitchFamily="49" charset="0"/>
                <a:ea typeface="新細明體" pitchFamily="18" charset="-120"/>
              </a:rPr>
              <a:t>W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</a:rPr>
              <a:t>   Y   I   T   L   G   W   G   L   P   S   V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   +270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766	TAC TTT TGG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</a:rPr>
              <a:t>TGG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TAT ATC ACA CTT GGA TGG GGT TTA CCT TCC GTT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	 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</a:rPr>
              <a:t>F   I   </a:t>
            </a:r>
            <a:r>
              <a:rPr lang="en-US" altLang="zh-TW" sz="1000" u="sng" dirty="0" err="1">
                <a:latin typeface="Courier New" pitchFamily="49" charset="0"/>
                <a:ea typeface="新細明體" pitchFamily="18" charset="-120"/>
              </a:rPr>
              <a:t>I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</a:rPr>
              <a:t>   A   W   S   I   A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R   Q   L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</a:rPr>
              <a:t>L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E   D   I      +285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811	TTT ATT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</a:rPr>
              <a:t>ATT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GCA TGG TCC ATT GCA AGG CAA CTG CTA GAA GAT ATA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	 G   C   W   D   I   N   I   N   A   E   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</a:rPr>
              <a:t>I   W   </a:t>
            </a:r>
            <a:r>
              <a:rPr lang="en-US" altLang="zh-TW" sz="1000" u="sng" dirty="0" err="1">
                <a:latin typeface="Courier New" pitchFamily="49" charset="0"/>
                <a:ea typeface="新細明體" pitchFamily="18" charset="-120"/>
              </a:rPr>
              <a:t>W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</a:rPr>
              <a:t>   I   </a:t>
            </a:r>
            <a:r>
              <a:rPr lang="en-US" altLang="zh-TW" sz="1000" u="sng" dirty="0" err="1">
                <a:latin typeface="Courier New" pitchFamily="49" charset="0"/>
                <a:ea typeface="新細明體" pitchFamily="18" charset="-120"/>
              </a:rPr>
              <a:t>I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   +300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856	GGG TGT TGG GAT ATC AAT ATA AAT GCT GAG ATC TGG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</a:rPr>
              <a:t>TGG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ATA ATT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	 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</a:rPr>
              <a:t>K   G   P   I   </a:t>
            </a:r>
            <a:r>
              <a:rPr lang="en-US" altLang="zh-TW" sz="1000" u="sng" dirty="0" err="1">
                <a:latin typeface="Courier New" pitchFamily="49" charset="0"/>
                <a:ea typeface="新細明體" pitchFamily="18" charset="-120"/>
              </a:rPr>
              <a:t>I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</a:rPr>
              <a:t>   L   S   I   F   I   N   F   I   L   F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   +315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901	AAA GGA CCT ATA ATT TTG TCC ATT TTT ATT AAT TTC ATT CTT TTT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	 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</a:rPr>
              <a:t>V   S   I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</a:rPr>
              <a:t>I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R   I   L   I   K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</a:rPr>
              <a:t>K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L   K   T   P   D      +330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946	GTA AGT ATC ATA AGA ATA TTG ATT AAA AAG TTA AAG ACA CCA GAT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	 V   R   G   S   N   F   N   Q   Y   K   R   L   A   K  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</a:rPr>
              <a:t> S 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  +345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991	GTG AGA GGA AGC AAC TTT AAT CAG TAC AAG AGA CTT GCA AAA TCC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	 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</a:rPr>
              <a:t>T   L   </a:t>
            </a:r>
            <a:r>
              <a:rPr lang="en-US" altLang="zh-TW" sz="1000" u="sng" dirty="0" err="1">
                <a:latin typeface="Courier New" pitchFamily="49" charset="0"/>
                <a:ea typeface="新細明體" pitchFamily="18" charset="-120"/>
              </a:rPr>
              <a:t>L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</a:rPr>
              <a:t>   </a:t>
            </a:r>
            <a:r>
              <a:rPr lang="en-US" altLang="zh-TW" sz="1000" u="sng" dirty="0" err="1">
                <a:latin typeface="Courier New" pitchFamily="49" charset="0"/>
                <a:ea typeface="新細明體" pitchFamily="18" charset="-120"/>
              </a:rPr>
              <a:t>L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</a:rPr>
              <a:t>   I   P   L   F   G   V   H   Y   I   T   F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   +360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1036	ACT TTG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</a:rPr>
              <a:t>TTG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TTA ATA CCT TTA TTT GGA GTA CAC TAT ATT ACA TTC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	 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</a:rPr>
              <a:t>T   I   F   P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E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</a:rPr>
              <a:t>E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V   S   A   V   T   A   E   I   R      +375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1081	ACA ATT TTT CCT GAG GAA GTT AGT GCT GTC ACA GCA GAA ATT CGA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	 L   Y   V   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</a:rPr>
              <a:t>E   L   A   V   G   S   F   Q   G   F   V   </a:t>
            </a:r>
            <a:r>
              <a:rPr lang="en-US" altLang="zh-TW" sz="1000" u="sng" dirty="0" err="1">
                <a:latin typeface="Courier New" pitchFamily="49" charset="0"/>
                <a:ea typeface="新細明體" pitchFamily="18" charset="-120"/>
              </a:rPr>
              <a:t>V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   +390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1126	TTA TAT GTT GAA CTT GCT GTT GGA TCT TTC CAG GGG TTT GTC GTT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	 </a:t>
            </a:r>
            <a:r>
              <a:rPr lang="en-US" altLang="zh-TW" sz="1000" u="sng" dirty="0">
                <a:latin typeface="Courier New" pitchFamily="49" charset="0"/>
                <a:ea typeface="新細明體" pitchFamily="18" charset="-120"/>
              </a:rPr>
              <a:t>A   V   L   Y   C   F   L   N   G   E   V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Q   S   E   I      +405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1171	GCT GTT CTC TAC TGT TTC CTT AAT GGA GAG GTT CAA TCT GAA ATC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	 K   R   K   W   R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</a:rPr>
              <a:t>R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W   K   L   K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</a:rPr>
              <a:t>K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H   F   D   V      +420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1216	AAA CGA AAA TGG AGA CGG TGG AAG TTA AAA AAG CAC TTT GAT GTA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	 D   F   R   H   P   R   N   S   T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</a:rPr>
              <a:t>T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S   N   G   T   N      +435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1261	GAT TTT CGA CAT CCT CGC AAC TCA ACA ACT AGC AAT GGA ACC AAT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	 G   M   T   L   V   S   L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</a:rPr>
              <a:t>L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T   R   S  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</a:rPr>
              <a:t>S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 P   K   D      +450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1306	GGC ATG ACC CTG GTT TCC CTG TTA ACC AGG TCT AGT CCA AAA GAT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	 Q   R   K   S   F   D   H   S   L   A   E   K   Y   .          +463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1351	CAA AGG AAA TCT TTT GAC CAC AGT CTG GCC GAA AAA TAC 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</a:rPr>
              <a:t>TGAaaca</a:t>
            </a: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</a:t>
            </a:r>
          </a:p>
          <a:p>
            <a:pPr>
              <a:lnSpc>
                <a:spcPct val="45000"/>
              </a:lnSpc>
              <a:spcBef>
                <a:spcPct val="50000"/>
              </a:spcBef>
            </a:pPr>
            <a:r>
              <a:rPr lang="en-US" altLang="zh-TW" sz="1000" dirty="0">
                <a:latin typeface="Courier New" pitchFamily="49" charset="0"/>
                <a:ea typeface="新細明體" pitchFamily="18" charset="-120"/>
              </a:rPr>
              <a:t>  1397	</a:t>
            </a:r>
            <a:r>
              <a:rPr lang="en-US" altLang="zh-TW" sz="1000" dirty="0" err="1">
                <a:latin typeface="Courier New" pitchFamily="49" charset="0"/>
                <a:ea typeface="新細明體" pitchFamily="18" charset="-120"/>
              </a:rPr>
              <a:t>taaaaaaactgaatttgtgaactataaagtgtaatactgtaaaaaaaaaaaa</a:t>
            </a:r>
            <a:endParaRPr lang="en-US" altLang="zh-TW" sz="1000" dirty="0">
              <a:latin typeface="Courier New" pitchFamily="49" charset="0"/>
              <a:ea typeface="新細明體" pitchFamily="18" charset="-120"/>
            </a:endParaRPr>
          </a:p>
          <a:p>
            <a:pPr>
              <a:lnSpc>
                <a:spcPct val="45000"/>
              </a:lnSpc>
              <a:spcBef>
                <a:spcPct val="50000"/>
              </a:spcBef>
            </a:pPr>
            <a:endParaRPr lang="en-US" altLang="zh-TW" sz="1000" dirty="0">
              <a:latin typeface="Courier New" pitchFamily="49" charset="0"/>
              <a:ea typeface="新細明體" pitchFamily="18" charset="-120"/>
            </a:endParaRPr>
          </a:p>
        </p:txBody>
      </p:sp>
      <p:sp>
        <p:nvSpPr>
          <p:cNvPr id="5124" name="Text Box 6"/>
          <p:cNvSpPr txBox="1">
            <a:spLocks noChangeArrowheads="1"/>
          </p:cNvSpPr>
          <p:nvPr/>
        </p:nvSpPr>
        <p:spPr bwMode="auto">
          <a:xfrm>
            <a:off x="4292600" y="3052763"/>
            <a:ext cx="576263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TW" sz="1000" b="1" i="1">
                <a:ea typeface="新細明體" pitchFamily="18" charset="-120"/>
              </a:rPr>
              <a:t>TM1</a:t>
            </a:r>
          </a:p>
        </p:txBody>
      </p:sp>
      <p:sp>
        <p:nvSpPr>
          <p:cNvPr id="5125" name="Text Box 7"/>
          <p:cNvSpPr txBox="1">
            <a:spLocks noChangeArrowheads="1"/>
          </p:cNvSpPr>
          <p:nvPr/>
        </p:nvSpPr>
        <p:spPr bwMode="auto">
          <a:xfrm>
            <a:off x="1196975" y="3916363"/>
            <a:ext cx="576263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TW" sz="1000" b="1" i="1">
                <a:ea typeface="新細明體" pitchFamily="18" charset="-120"/>
              </a:rPr>
              <a:t>TM2</a:t>
            </a:r>
          </a:p>
        </p:txBody>
      </p:sp>
      <p:sp>
        <p:nvSpPr>
          <p:cNvPr id="5126" name="Text Box 8"/>
          <p:cNvSpPr txBox="1">
            <a:spLocks noChangeArrowheads="1"/>
          </p:cNvSpPr>
          <p:nvPr/>
        </p:nvSpPr>
        <p:spPr bwMode="auto">
          <a:xfrm>
            <a:off x="3929063" y="4524375"/>
            <a:ext cx="576262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TW" sz="1000" b="1" i="1">
                <a:ea typeface="新細明體" pitchFamily="18" charset="-120"/>
              </a:rPr>
              <a:t>TM3</a:t>
            </a:r>
          </a:p>
        </p:txBody>
      </p:sp>
      <p:sp>
        <p:nvSpPr>
          <p:cNvPr id="5127" name="Text Box 9"/>
          <p:cNvSpPr txBox="1">
            <a:spLocks noChangeArrowheads="1"/>
          </p:cNvSpPr>
          <p:nvPr/>
        </p:nvSpPr>
        <p:spPr bwMode="auto">
          <a:xfrm>
            <a:off x="908050" y="5356225"/>
            <a:ext cx="576263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TW" sz="1000" b="1" i="1">
                <a:ea typeface="新細明體" pitchFamily="18" charset="-120"/>
              </a:rPr>
              <a:t>TM4</a:t>
            </a:r>
          </a:p>
        </p:txBody>
      </p:sp>
      <p:sp>
        <p:nvSpPr>
          <p:cNvPr id="5128" name="Text Box 10"/>
          <p:cNvSpPr txBox="1">
            <a:spLocks noChangeArrowheads="1"/>
          </p:cNvSpPr>
          <p:nvPr/>
        </p:nvSpPr>
        <p:spPr bwMode="auto">
          <a:xfrm>
            <a:off x="3933825" y="5932488"/>
            <a:ext cx="576263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TW" sz="1000" b="1" i="1">
                <a:ea typeface="新細明體" pitchFamily="18" charset="-120"/>
              </a:rPr>
              <a:t>TM5</a:t>
            </a:r>
          </a:p>
        </p:txBody>
      </p:sp>
      <p:sp>
        <p:nvSpPr>
          <p:cNvPr id="5129" name="Text Box 11"/>
          <p:cNvSpPr txBox="1">
            <a:spLocks noChangeArrowheads="1"/>
          </p:cNvSpPr>
          <p:nvPr/>
        </p:nvSpPr>
        <p:spPr bwMode="auto">
          <a:xfrm>
            <a:off x="5157788" y="6824663"/>
            <a:ext cx="576262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TW" sz="1000" b="1" i="1">
                <a:ea typeface="新細明體" pitchFamily="18" charset="-120"/>
              </a:rPr>
              <a:t>TM6</a:t>
            </a:r>
          </a:p>
        </p:txBody>
      </p:sp>
      <p:sp>
        <p:nvSpPr>
          <p:cNvPr id="5130" name="Text Box 12"/>
          <p:cNvSpPr txBox="1">
            <a:spLocks noChangeArrowheads="1"/>
          </p:cNvSpPr>
          <p:nvPr/>
        </p:nvSpPr>
        <p:spPr bwMode="auto">
          <a:xfrm>
            <a:off x="1852613" y="7667625"/>
            <a:ext cx="576262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TW" sz="1000" b="1" i="1">
                <a:ea typeface="新細明體" pitchFamily="18" charset="-120"/>
              </a:rPr>
              <a:t>TM7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</Words>
  <Application>Microsoft Office PowerPoint</Application>
  <PresentationFormat>A4 Paper (210x297 mm)</PresentationFormat>
  <Paragraphs>7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Grizli777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nice</dc:creator>
  <cp:lastModifiedBy>Janice</cp:lastModifiedBy>
  <cp:revision>1</cp:revision>
  <dcterms:created xsi:type="dcterms:W3CDTF">2011-04-07T14:04:41Z</dcterms:created>
  <dcterms:modified xsi:type="dcterms:W3CDTF">2011-04-07T14:05:07Z</dcterms:modified>
</cp:coreProperties>
</file>